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png" ContentType="image/pn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57" r:id="rId2"/>
  </p:sldIdLst>
  <p:sldSz cx="6858000" cy="795496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88"/>
    <p:restoredTop sz="94634"/>
  </p:normalViewPr>
  <p:slideViewPr>
    <p:cSldViewPr snapToGrid="0" snapToObjects="1">
      <p:cViewPr varScale="1">
        <p:scale>
          <a:sx n="148" d="100"/>
          <a:sy n="148" d="100"/>
        </p:scale>
        <p:origin x="1672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F5E48B-D26F-FA41-8FCA-53E0C9A37578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8675" y="1143000"/>
            <a:ext cx="2660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3F347A4-5D7D-C245-8A3A-4769C9E6889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54694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98675" y="1143000"/>
            <a:ext cx="26606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Fig S1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9B9B4A-B11C-4B77-93A2-280D7484DD3E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794937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1889"/>
            <a:ext cx="5829300" cy="27695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178198"/>
            <a:ext cx="5143500" cy="192060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3528"/>
            <a:ext cx="1478756" cy="674146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3528"/>
            <a:ext cx="4350544" cy="674146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83219"/>
            <a:ext cx="5915025" cy="33090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23566"/>
            <a:ext cx="5915025" cy="17401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17641"/>
            <a:ext cx="2914650" cy="5047351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3530"/>
            <a:ext cx="5915025" cy="153759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50071"/>
            <a:ext cx="2901255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05771"/>
            <a:ext cx="2901255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50071"/>
            <a:ext cx="2915543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05771"/>
            <a:ext cx="2915543" cy="4273952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45369"/>
            <a:ext cx="3471863" cy="56531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45369"/>
            <a:ext cx="3471863" cy="56531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Drag picture to placeholder or click icon to add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3530"/>
            <a:ext cx="5915025" cy="1537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17641"/>
            <a:ext cx="5915025" cy="50473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115095-1AD6-9F4C-BC6D-1D9D36D95FC6}" type="datetimeFigureOut">
              <a:rPr lang="en-US" smtClean="0"/>
              <a:t>12/18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373074"/>
            <a:ext cx="2314575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3E6081-0BA3-FC4A-880A-E67C576566F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14586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4" Type="http://schemas.openxmlformats.org/officeDocument/2006/relationships/image" Target="../media/image2.png"/><Relationship Id="rId5" Type="http://schemas.openxmlformats.org/officeDocument/2006/relationships/image" Target="../media/image3.png"/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438900" y="632535"/>
            <a:ext cx="4650173" cy="176199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 rot="16200000">
            <a:off x="206169" y="1376124"/>
            <a:ext cx="2143716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Occupancy (RPM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1726649" y="2801435"/>
            <a:ext cx="4180799" cy="4619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verage Med15 and Med17 Occupancy in </a:t>
            </a:r>
            <a:r>
              <a:rPr lang="en-US" sz="1201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8∆ kin28-AA</a:t>
            </a:r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st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454510" y="5073977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k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2854091" y="5084022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k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4335742" y="5073975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kb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849650" y="5073975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5791239" y="5073975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kb</a:t>
            </a:r>
          </a:p>
        </p:txBody>
      </p:sp>
      <p:cxnSp>
        <p:nvCxnSpPr>
          <p:cNvPr id="12" name="Straight Arrow Connector 11"/>
          <p:cNvCxnSpPr/>
          <p:nvPr/>
        </p:nvCxnSpPr>
        <p:spPr>
          <a:xfrm>
            <a:off x="2764626" y="5571240"/>
            <a:ext cx="2341979" cy="25326"/>
          </a:xfrm>
          <a:prstGeom prst="straightConnector1">
            <a:avLst/>
          </a:prstGeom>
          <a:ln w="381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3" name="Straight Arrow Connector 12"/>
          <p:cNvCxnSpPr/>
          <p:nvPr/>
        </p:nvCxnSpPr>
        <p:spPr>
          <a:xfrm>
            <a:off x="3146665" y="5943088"/>
            <a:ext cx="1820023" cy="16073"/>
          </a:xfrm>
          <a:prstGeom prst="straightConnector1">
            <a:avLst/>
          </a:prstGeom>
          <a:ln w="38100" cmpd="sng">
            <a:solidFill>
              <a:schemeClr val="tx1"/>
            </a:solidFill>
            <a:tailEnd type="arrow"/>
          </a:ln>
          <a:effectLst/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2568814" y="5303646"/>
            <a:ext cx="446811" cy="2770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3" tIns="45702" rIns="91403" bIns="45702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35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1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0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15" name="TextBox 147"/>
          <p:cNvSpPr txBox="1">
            <a:spLocks noChangeArrowheads="1"/>
          </p:cNvSpPr>
          <p:nvPr/>
        </p:nvSpPr>
        <p:spPr bwMode="auto">
          <a:xfrm>
            <a:off x="3007312" y="5682198"/>
            <a:ext cx="660855" cy="27709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lIns="91403" tIns="45702" rIns="91403" bIns="45702">
            <a:spAutoFit/>
          </a:bodyPr>
          <a:lstStyle>
            <a:lvl1pPr>
              <a:spcBef>
                <a:spcPct val="20000"/>
              </a:spcBef>
              <a:buFont typeface="Arial" panose="020B0604020202020204" pitchFamily="34" charset="0"/>
              <a:buChar char="•"/>
              <a:defRPr sz="13500"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spcBef>
                <a:spcPct val="20000"/>
              </a:spcBef>
              <a:buFont typeface="Arial" panose="020B0604020202020204" pitchFamily="34" charset="0"/>
              <a:buChar char="–"/>
              <a:defRPr sz="11800"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spcBef>
                <a:spcPct val="20000"/>
              </a:spcBef>
              <a:buFont typeface="Arial" panose="020B0604020202020204" pitchFamily="34" charset="0"/>
              <a:buChar char="•"/>
              <a:defRPr sz="10100"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spcBef>
                <a:spcPct val="20000"/>
              </a:spcBef>
              <a:buFont typeface="Arial" panose="020B0604020202020204" pitchFamily="34" charset="0"/>
              <a:buChar char="–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spcBef>
                <a:spcPct val="20000"/>
              </a:spcBef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1768475" eaLnBrk="0" fontAlgn="base" hangingPunct="0">
              <a:spcBef>
                <a:spcPct val="20000"/>
              </a:spcBef>
              <a:spcAft>
                <a:spcPct val="0"/>
              </a:spcAft>
              <a:buFont typeface="Arial" panose="020B0604020202020204" pitchFamily="34" charset="0"/>
              <a:buChar char="»"/>
              <a:defRPr sz="8500"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en-US" alt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1949571" y="340572"/>
            <a:ext cx="3485554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Untagged control </a:t>
            </a:r>
            <a:r>
              <a:rPr lang="en-US" sz="1201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kin28-AA</a:t>
            </a:r>
            <a:r>
              <a:rPr lang="en-US" sz="1201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yeast</a:t>
            </a:r>
          </a:p>
        </p:txBody>
      </p:sp>
      <p:pic>
        <p:nvPicPr>
          <p:cNvPr id="17" name="Picture 16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416526" y="3073898"/>
            <a:ext cx="4672546" cy="2000077"/>
          </a:xfrm>
          <a:prstGeom prst="rect">
            <a:avLst/>
          </a:prstGeom>
        </p:spPr>
      </p:pic>
      <p:pic>
        <p:nvPicPr>
          <p:cNvPr id="18" name="Picture 17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316395" y="3235746"/>
            <a:ext cx="1001307" cy="344821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354655" y="2386981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2kb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792219" y="2386980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 1kb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4339915" y="2386980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-1kb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4853823" y="2374467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ES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5791239" y="2386980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2kb</a:t>
            </a:r>
          </a:p>
        </p:txBody>
      </p:sp>
      <p:sp>
        <p:nvSpPr>
          <p:cNvPr id="25" name="TextBox 24"/>
          <p:cNvSpPr txBox="1"/>
          <p:nvPr/>
        </p:nvSpPr>
        <p:spPr>
          <a:xfrm rot="16200000">
            <a:off x="206169" y="3869351"/>
            <a:ext cx="2143716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 dirty="0">
                <a:latin typeface="Times New Roman" panose="02020603050405020304" pitchFamily="18" charset="0"/>
                <a:cs typeface="Times New Roman" panose="02020603050405020304" pitchFamily="18" charset="0"/>
              </a:rPr>
              <a:t>Normalized Occupancy (RPM)</a:t>
            </a:r>
          </a:p>
        </p:txBody>
      </p:sp>
      <p:sp>
        <p:nvSpPr>
          <p:cNvPr id="34" name="Rectangle 33"/>
          <p:cNvSpPr/>
          <p:nvPr/>
        </p:nvSpPr>
        <p:spPr>
          <a:xfrm>
            <a:off x="5106604" y="727365"/>
            <a:ext cx="878561" cy="103909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40" name="Rectangle 39"/>
          <p:cNvSpPr/>
          <p:nvPr/>
        </p:nvSpPr>
        <p:spPr>
          <a:xfrm>
            <a:off x="3480956" y="3235746"/>
            <a:ext cx="854787" cy="344821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39" name="TextBox 38"/>
          <p:cNvSpPr txBox="1"/>
          <p:nvPr/>
        </p:nvSpPr>
        <p:spPr>
          <a:xfrm>
            <a:off x="3339726" y="3200406"/>
            <a:ext cx="705243" cy="4154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5</a:t>
            </a:r>
            <a:endParaRPr lang="en-US" sz="1050" dirty="0">
              <a:latin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050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17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2371192" y="5085073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1">
                <a:latin typeface="Times New Roman" panose="02020603050405020304" pitchFamily="18" charset="0"/>
                <a:cs typeface="Times New Roman" panose="02020603050405020304" pitchFamily="18" charset="0"/>
              </a:rPr>
              <a:t>0kb</a:t>
            </a:r>
            <a:endParaRPr 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Straight Connector 29"/>
          <p:cNvCxnSpPr/>
          <p:nvPr/>
        </p:nvCxnSpPr>
        <p:spPr>
          <a:xfrm>
            <a:off x="3137700" y="4919095"/>
            <a:ext cx="0" cy="170384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Straight Connector 30"/>
          <p:cNvCxnSpPr/>
          <p:nvPr/>
        </p:nvCxnSpPr>
        <p:spPr>
          <a:xfrm>
            <a:off x="2764625" y="4918139"/>
            <a:ext cx="0" cy="170384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2316794" y="2386691"/>
            <a:ext cx="513908" cy="27712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1">
                <a:latin typeface="Times New Roman" panose="02020603050405020304" pitchFamily="18" charset="0"/>
                <a:cs typeface="Times New Roman" panose="02020603050405020304" pitchFamily="18" charset="0"/>
              </a:rPr>
              <a:t>  </a:t>
            </a:r>
            <a:r>
              <a:rPr lang="en-US" sz="1201">
                <a:latin typeface="Times New Roman" panose="02020603050405020304" pitchFamily="18" charset="0"/>
                <a:cs typeface="Times New Roman" panose="02020603050405020304" pitchFamily="18" charset="0"/>
              </a:rPr>
              <a:t>0kb</a:t>
            </a:r>
            <a:endParaRPr lang="en-US" sz="120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6" name="Straight Connector 35"/>
          <p:cNvCxnSpPr/>
          <p:nvPr/>
        </p:nvCxnSpPr>
        <p:spPr>
          <a:xfrm>
            <a:off x="3083302" y="2238645"/>
            <a:ext cx="0" cy="170384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/>
          <p:nvPr/>
        </p:nvCxnSpPr>
        <p:spPr>
          <a:xfrm>
            <a:off x="2710227" y="2237688"/>
            <a:ext cx="0" cy="170384"/>
          </a:xfrm>
          <a:prstGeom prst="line">
            <a:avLst/>
          </a:prstGeom>
          <a:ln w="19050">
            <a:solidFill>
              <a:srgbClr val="00B05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824753" y="6795248"/>
            <a:ext cx="1676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3 Fig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67193220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55</Words>
  <Application>Microsoft Macintosh PowerPoint</Application>
  <PresentationFormat>Custom</PresentationFormat>
  <Paragraphs>2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orse, Randall H (HEALTH)</dc:creator>
  <cp:lastModifiedBy>Morse, Randall H (HEALTH)</cp:lastModifiedBy>
  <cp:revision>1</cp:revision>
  <dcterms:created xsi:type="dcterms:W3CDTF">2017-12-18T19:36:56Z</dcterms:created>
  <dcterms:modified xsi:type="dcterms:W3CDTF">2017-12-18T19:37:24Z</dcterms:modified>
</cp:coreProperties>
</file>